
<file path=[Content_Types].xml><?xml version="1.0" encoding="utf-8"?>
<Types xmlns="http://schemas.openxmlformats.org/package/2006/content-types">
  <Default ContentType="application/x-fontdata" Extension="fntdata"/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60" r:id="rId4"/>
  </p:sldMasterIdLst>
  <p:notesMasterIdLst>
    <p:notesMasterId r:id="rId5"/>
  </p:notesMasterIdLst>
  <p:sldIdLst>
    <p:sldId id="256" r:id="rId6"/>
  </p:sldIdLst>
  <p:sldSz cy="5143500" cx="9144000"/>
  <p:notesSz cx="6858000" cy="9144000"/>
  <p:embeddedFontLst>
    <p:embeddedFont>
      <p:font typeface="Garamond"/>
      <p:regular r:id="rId7"/>
      <p:bold r:id="rId8"/>
      <p:italic r:id="rId9"/>
      <p:boldItalic r:id="rId10"/>
    </p:embeddedFont>
    <p:embeddedFont>
      <p:font typeface="Spectral"/>
      <p:regular r:id="rId11"/>
      <p:bold r:id="rId12"/>
      <p:italic r:id="rId13"/>
      <p:boldItalic r:id="rId14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1" Type="http://schemas.openxmlformats.org/officeDocument/2006/relationships/font" Target="fonts/Spectral-regular.fntdata"/><Relationship Id="rId10" Type="http://schemas.openxmlformats.org/officeDocument/2006/relationships/font" Target="fonts/Garamond-boldItalic.fntdata"/><Relationship Id="rId13" Type="http://schemas.openxmlformats.org/officeDocument/2006/relationships/font" Target="fonts/Spectral-italic.fntdata"/><Relationship Id="rId12" Type="http://schemas.openxmlformats.org/officeDocument/2006/relationships/font" Target="fonts/Spectral-bold.fntdata"/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font" Target="fonts/Garamond-italic.fntdata"/><Relationship Id="rId14" Type="http://schemas.openxmlformats.org/officeDocument/2006/relationships/font" Target="fonts/Spectral-boldItalic.fntdata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font" Target="fonts/Garamond-regular.fntdata"/><Relationship Id="rId8" Type="http://schemas.openxmlformats.org/officeDocument/2006/relationships/font" Target="fonts/Garamond-bold.fnt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2c778076ed4_0_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2c778076ed4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ullet Slide-White">
  <p:cSld name="Bullet Slide-White">
    <p:bg>
      <p:bgPr>
        <a:solidFill>
          <a:schemeClr val="lt1"/>
        </a:solidFill>
      </p:bgPr>
    </p:bg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/>
          <p:nvPr>
            <p:ph idx="11" type="ftr"/>
          </p:nvPr>
        </p:nvSpPr>
        <p:spPr>
          <a:xfrm>
            <a:off x="548153" y="4852598"/>
            <a:ext cx="4311000" cy="103500"/>
          </a:xfrm>
          <a:prstGeom prst="rect">
            <a:avLst/>
          </a:prstGeom>
          <a:noFill/>
          <a:ln>
            <a:noFill/>
          </a:ln>
        </p:spPr>
        <p:txBody>
          <a:bodyPr anchorCtr="0" anchor="b" bIns="0" lIns="0" spcFirstLastPara="1" rIns="0" wrap="square" tIns="0">
            <a:noAutofit/>
          </a:bodyPr>
          <a:lstStyle>
            <a:lvl1pPr lvl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2" type="sldNum"/>
          </p:nvPr>
        </p:nvSpPr>
        <p:spPr>
          <a:xfrm>
            <a:off x="272108" y="4840129"/>
            <a:ext cx="246000" cy="116400"/>
          </a:xfrm>
          <a:prstGeom prst="rect">
            <a:avLst/>
          </a:prstGeom>
          <a:noFill/>
          <a:ln>
            <a:noFill/>
          </a:ln>
        </p:spPr>
        <p:txBody>
          <a:bodyPr anchorCtr="0" anchor="b" bIns="0" lIns="0" spcFirstLastPara="1" rIns="0" wrap="square" tIns="0">
            <a:normAutofit fontScale="92500" lnSpcReduction="20000"/>
          </a:bodyPr>
          <a:lstStyle>
            <a:lvl1pPr indent="0" lvl="0" marL="0" rtl="0" algn="l">
              <a:spcBef>
                <a:spcPts val="0"/>
              </a:spcBef>
              <a:buNone/>
              <a:defRPr/>
            </a:lvl1pPr>
            <a:lvl2pPr indent="0" lvl="1" marL="0" rtl="0" algn="l">
              <a:spcBef>
                <a:spcPts val="0"/>
              </a:spcBef>
              <a:buNone/>
              <a:defRPr/>
            </a:lvl2pPr>
            <a:lvl3pPr indent="0" lvl="2" marL="0" rtl="0" algn="l">
              <a:spcBef>
                <a:spcPts val="0"/>
              </a:spcBef>
              <a:buNone/>
              <a:defRPr/>
            </a:lvl3pPr>
            <a:lvl4pPr indent="0" lvl="3" marL="0" rtl="0" algn="l">
              <a:spcBef>
                <a:spcPts val="0"/>
              </a:spcBef>
              <a:buNone/>
              <a:defRPr/>
            </a:lvl4pPr>
            <a:lvl5pPr indent="0" lvl="4" marL="0" rtl="0" algn="l">
              <a:spcBef>
                <a:spcPts val="0"/>
              </a:spcBef>
              <a:buNone/>
              <a:defRPr/>
            </a:lvl5pPr>
            <a:lvl6pPr indent="0" lvl="5" marL="0" rtl="0" algn="l">
              <a:spcBef>
                <a:spcPts val="0"/>
              </a:spcBef>
              <a:buNone/>
              <a:defRPr/>
            </a:lvl6pPr>
            <a:lvl7pPr indent="0" lvl="6" marL="0" rtl="0" algn="l">
              <a:spcBef>
                <a:spcPts val="0"/>
              </a:spcBef>
              <a:buNone/>
              <a:defRPr/>
            </a:lvl7pPr>
            <a:lvl8pPr indent="0" lvl="7" marL="0" rtl="0" algn="l">
              <a:spcBef>
                <a:spcPts val="0"/>
              </a:spcBef>
              <a:buNone/>
              <a:defRPr/>
            </a:lvl8pPr>
            <a:lvl9pPr indent="0" lvl="8" marL="0" rtl="0" algn="l">
              <a:spcBef>
                <a:spcPts val="0"/>
              </a:spcBef>
              <a:buNone/>
              <a:defRPr/>
            </a:lvl9pPr>
          </a:lstStyle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53" name="Google Shape;53;p13"/>
          <p:cNvSpPr txBox="1"/>
          <p:nvPr>
            <p:ph type="title"/>
          </p:nvPr>
        </p:nvSpPr>
        <p:spPr>
          <a:xfrm>
            <a:off x="453585" y="318752"/>
            <a:ext cx="8173500" cy="4587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rt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Garamond"/>
              <a:buNone/>
              <a:defRPr sz="3600">
                <a:latin typeface="Garamond"/>
                <a:ea typeface="Garamond"/>
                <a:cs typeface="Garamond"/>
                <a:sym typeface="Garamond"/>
              </a:defRPr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54" name="Google Shape;54;p13"/>
          <p:cNvSpPr txBox="1"/>
          <p:nvPr>
            <p:ph idx="1" type="body"/>
          </p:nvPr>
        </p:nvSpPr>
        <p:spPr>
          <a:xfrm>
            <a:off x="457202" y="695742"/>
            <a:ext cx="81699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  <a:defRPr i="0" sz="1800">
                <a:latin typeface="Arial"/>
                <a:ea typeface="Arial"/>
                <a:cs typeface="Arial"/>
                <a:sym typeface="Arial"/>
              </a:defRPr>
            </a:lvl1pPr>
            <a:lvl2pPr indent="-228600" lvl="1" marL="914400" rtl="0" algn="l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SzPts val="2000"/>
              <a:buNone/>
              <a:defRPr i="1">
                <a:latin typeface="Arial"/>
                <a:ea typeface="Arial"/>
                <a:cs typeface="Arial"/>
                <a:sym typeface="Arial"/>
              </a:defRPr>
            </a:lvl2pPr>
            <a:lvl3pPr indent="-228600" lvl="2" marL="1371600" rtl="0" algn="l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SzPts val="1440"/>
              <a:buNone/>
              <a:defRPr i="1">
                <a:latin typeface="Arial"/>
                <a:ea typeface="Arial"/>
                <a:cs typeface="Arial"/>
                <a:sym typeface="Arial"/>
              </a:defRPr>
            </a:lvl3pPr>
            <a:lvl4pPr indent="-228600" lvl="3" marL="1828800" rtl="0" algn="l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SzPts val="1600"/>
              <a:buNone/>
              <a:defRPr i="1">
                <a:latin typeface="Arial"/>
                <a:ea typeface="Arial"/>
                <a:cs typeface="Arial"/>
                <a:sym typeface="Arial"/>
              </a:defRPr>
            </a:lvl4pPr>
            <a:lvl5pPr indent="-228600" lvl="4" marL="2286000" rtl="0" algn="l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SzPts val="1600"/>
              <a:buNone/>
              <a:defRPr i="1">
                <a:latin typeface="Arial"/>
                <a:ea typeface="Arial"/>
                <a:cs typeface="Arial"/>
                <a:sym typeface="Arial"/>
              </a:defRPr>
            </a:lvl5pPr>
            <a:lvl6pPr indent="-342900" lvl="5" marL="274320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800"/>
              <a:buChar char="■"/>
              <a:defRPr/>
            </a:lvl6pPr>
            <a:lvl7pPr indent="-342900" lvl="6" marL="320040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  <a:defRPr/>
            </a:lvl7pPr>
            <a:lvl8pPr indent="-342900" lvl="7" marL="365760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800"/>
              <a:buChar char="○"/>
              <a:defRPr/>
            </a:lvl8pPr>
            <a:lvl9pPr indent="-342900" lvl="8" marL="4114800" rtl="0" algn="l">
              <a:spcBef>
                <a:spcPts val="1200"/>
              </a:spcBef>
              <a:spcAft>
                <a:spcPts val="1200"/>
              </a:spcAft>
              <a:buClr>
                <a:schemeClr val="dk1"/>
              </a:buClr>
              <a:buSzPts val="1800"/>
              <a:buChar char="■"/>
              <a:defRPr/>
            </a:lvl9pPr>
          </a:lstStyle>
          <a:p/>
        </p:txBody>
      </p:sp>
      <p:sp>
        <p:nvSpPr>
          <p:cNvPr id="55" name="Google Shape;55;p13"/>
          <p:cNvSpPr txBox="1"/>
          <p:nvPr>
            <p:ph idx="2" type="body"/>
          </p:nvPr>
        </p:nvSpPr>
        <p:spPr>
          <a:xfrm>
            <a:off x="459686" y="1401418"/>
            <a:ext cx="8137800" cy="29319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20040" lvl="0" marL="45720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●"/>
              <a:defRPr/>
            </a:lvl1pPr>
            <a:lvl2pPr indent="-342900" lvl="1" marL="914400" rtl="0" algn="l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SzPts val="1800"/>
              <a:buChar char="○"/>
              <a:defRPr/>
            </a:lvl2pPr>
            <a:lvl3pPr indent="-320039" lvl="2" marL="1371600" rtl="0" algn="l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SzPts val="1440"/>
              <a:buChar char="■"/>
              <a:defRPr/>
            </a:lvl3pPr>
            <a:lvl4pPr indent="-342900" lvl="3" marL="1828800" rtl="0" algn="l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SzPts val="1800"/>
              <a:buChar char="●"/>
              <a:defRPr/>
            </a:lvl4pPr>
            <a:lvl5pPr indent="-320039" lvl="4" marL="2286000" rtl="0" algn="l">
              <a:lnSpc>
                <a:spcPct val="200000"/>
              </a:lnSpc>
              <a:spcBef>
                <a:spcPts val="600"/>
              </a:spcBef>
              <a:spcAft>
                <a:spcPts val="0"/>
              </a:spcAft>
              <a:buSzPts val="1440"/>
              <a:buChar char="○"/>
              <a:defRPr/>
            </a:lvl5pPr>
            <a:lvl6pPr indent="-342900" lvl="5" marL="274320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800"/>
              <a:buChar char="■"/>
              <a:defRPr/>
            </a:lvl6pPr>
            <a:lvl7pPr indent="-342900" lvl="6" marL="320040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  <a:defRPr/>
            </a:lvl7pPr>
            <a:lvl8pPr indent="-342900" lvl="7" marL="365760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800"/>
              <a:buChar char="○"/>
              <a:defRPr/>
            </a:lvl8pPr>
            <a:lvl9pPr indent="-342900" lvl="8" marL="4114800" rtl="0" algn="l">
              <a:spcBef>
                <a:spcPts val="1200"/>
              </a:spcBef>
              <a:spcAft>
                <a:spcPts val="1200"/>
              </a:spcAft>
              <a:buClr>
                <a:schemeClr val="dk1"/>
              </a:buClr>
              <a:buSzPts val="1800"/>
              <a:buChar char="■"/>
              <a:defRPr/>
            </a:lvl9pPr>
          </a:lstStyle>
          <a:p/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hyperlink" Target="https://app.smartsheet.com/b/form/721f2127cd5448458d16843a7128ec6d" TargetMode="Externa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 txBox="1"/>
          <p:nvPr/>
        </p:nvSpPr>
        <p:spPr>
          <a:xfrm>
            <a:off x="0" y="126250"/>
            <a:ext cx="8773200" cy="5332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6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Introducing a</a:t>
            </a:r>
            <a:r>
              <a:rPr b="1" lang="en" sz="16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 </a:t>
            </a:r>
            <a:r>
              <a:rPr lang="en" sz="16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series for GME Faculty Leaders:</a:t>
            </a:r>
            <a:endParaRPr sz="16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2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Microaggressions in the Learning Environment</a:t>
            </a:r>
            <a:endParaRPr b="1" sz="25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We invite all GME faculty in leadership positions to attend this iterative four-part series during the 2021-2022 academic year as we build a more inclusive learning environment for our residents and students. We welcome you to join </a:t>
            </a:r>
            <a:r>
              <a:rPr lang="en" sz="1500" u="sng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ANY</a:t>
            </a:r>
            <a:r>
              <a:rPr lang="en" sz="1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 or </a:t>
            </a:r>
            <a:r>
              <a:rPr lang="en" sz="1500" u="sng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ALL</a:t>
            </a:r>
            <a:r>
              <a:rPr lang="en" sz="1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 sessions to meet your learning needs!</a:t>
            </a:r>
            <a:endParaRPr sz="16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2000" u="sng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Session #1: Acknowledging and Naming Microaggresions</a:t>
            </a:r>
            <a:endParaRPr b="1" sz="2000" u="sng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en" sz="1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Who is this for?</a:t>
            </a:r>
            <a:r>
              <a:rPr lang="en" sz="1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 Anyone with situational power. You do not need to have any prior training in diversity/equity/inclusion. </a:t>
            </a:r>
            <a:endParaRPr sz="15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en" sz="1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What will I learn?</a:t>
            </a:r>
            <a:r>
              <a:rPr lang="en" sz="1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 This session will focus on self-awareness, defining bias, privilege, and microaggressions, and recognizing and naming bias in the learning environment.</a:t>
            </a:r>
            <a:endParaRPr sz="15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en" sz="15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When will it be? </a:t>
            </a:r>
            <a:endParaRPr b="1" i="1" sz="15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457200" lvl="0" marL="91440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500">
                <a:solidFill>
                  <a:srgbClr val="506380"/>
                </a:solidFill>
                <a:latin typeface="Spectral"/>
                <a:ea typeface="Spectral"/>
                <a:cs typeface="Spectral"/>
                <a:sym typeface="Spectral"/>
              </a:rPr>
              <a:t>Virtual session - August 30, 2021 from 10a-12p</a:t>
            </a:r>
            <a:endParaRPr b="1" sz="1500">
              <a:solidFill>
                <a:srgbClr val="506380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500">
                <a:solidFill>
                  <a:srgbClr val="506380"/>
                </a:solidFill>
                <a:latin typeface="Spectral"/>
                <a:ea typeface="Spectral"/>
                <a:cs typeface="Spectral"/>
                <a:sym typeface="Spectral"/>
              </a:rPr>
              <a:t>                             Virtual session- September 20, 2021 from 10a-12p</a:t>
            </a:r>
            <a:endParaRPr sz="1500">
              <a:solidFill>
                <a:srgbClr val="506380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2100" u="sng">
                <a:solidFill>
                  <a:srgbClr val="178CCB"/>
                </a:solidFill>
                <a:latin typeface="Spectral"/>
                <a:ea typeface="Spectral"/>
                <a:cs typeface="Spectral"/>
                <a:sym typeface="Spectral"/>
                <a:hlinkClick r:id="rId3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Sign up here!</a:t>
            </a:r>
            <a:endParaRPr sz="1100">
              <a:solidFill>
                <a:srgbClr val="178CCB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1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100">
                <a:solidFill>
                  <a:srgbClr val="052049"/>
                </a:solidFill>
                <a:latin typeface="Spectral"/>
                <a:ea typeface="Spectral"/>
                <a:cs typeface="Spectral"/>
                <a:sym typeface="Spectral"/>
              </a:rPr>
              <a:t>For questions, please email …</a:t>
            </a:r>
            <a:endParaRPr sz="11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rgbClr val="052049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300">
                <a:solidFill>
                  <a:srgbClr val="052049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endParaRPr sz="300">
              <a:solidFill>
                <a:srgbClr val="052049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>
                <a:solidFill>
                  <a:srgbClr val="052049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ME Credit will be available.</a:t>
            </a:r>
            <a:endParaRPr sz="1000">
              <a:solidFill>
                <a:srgbClr val="052049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chemeClr val="dk1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chemeClr val="dk1"/>
              </a:solidFill>
              <a:latin typeface="Spectral"/>
              <a:ea typeface="Spectral"/>
              <a:cs typeface="Spectral"/>
              <a:sym typeface="Spectral"/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chemeClr val="dk1"/>
              </a:solidFill>
              <a:latin typeface="Spectral"/>
              <a:ea typeface="Spectral"/>
              <a:cs typeface="Spectral"/>
              <a:sym typeface="Spectr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